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1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7936C-71EE-4F1F-A508-74D613ABD13A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46ADD-F13D-4B4D-B9F1-BF5676DEE51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6950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7936C-71EE-4F1F-A508-74D613ABD13A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46ADD-F13D-4B4D-B9F1-BF5676DEE51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2176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7936C-71EE-4F1F-A508-74D613ABD13A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46ADD-F13D-4B4D-B9F1-BF5676DEE51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5560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7936C-71EE-4F1F-A508-74D613ABD13A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46ADD-F13D-4B4D-B9F1-BF5676DEE51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3474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7936C-71EE-4F1F-A508-74D613ABD13A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46ADD-F13D-4B4D-B9F1-BF5676DEE51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3882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7936C-71EE-4F1F-A508-74D613ABD13A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46ADD-F13D-4B4D-B9F1-BF5676DEE51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0798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7936C-71EE-4F1F-A508-74D613ABD13A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46ADD-F13D-4B4D-B9F1-BF5676DEE51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8639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7936C-71EE-4F1F-A508-74D613ABD13A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46ADD-F13D-4B4D-B9F1-BF5676DEE51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7759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7936C-71EE-4F1F-A508-74D613ABD13A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46ADD-F13D-4B4D-B9F1-BF5676DEE51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8308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7936C-71EE-4F1F-A508-74D613ABD13A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46ADD-F13D-4B4D-B9F1-BF5676DEE51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7702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7936C-71EE-4F1F-A508-74D613ABD13A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46ADD-F13D-4B4D-B9F1-BF5676DEE51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68953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F7936C-71EE-4F1F-A508-74D613ABD13A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846ADD-F13D-4B4D-B9F1-BF5676DEE51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1890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6695" y="226942"/>
            <a:ext cx="6785113" cy="5444987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336430" y="5580214"/>
            <a:ext cx="11524891" cy="6850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GB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6.</a:t>
            </a:r>
            <a:r>
              <a:rPr lang="en-GB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tic relationships within non-redundant lentil accessions genotyped in this study. The </a:t>
            </a:r>
            <a:r>
              <a:rPr lang="en-GB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ndrogram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s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sed on the allele sharing distance and the Ward’s clustering algorithm. 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579011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>DZ-Forum.n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Utente</cp:lastModifiedBy>
  <cp:revision>5</cp:revision>
  <dcterms:created xsi:type="dcterms:W3CDTF">2019-04-29T13:22:47Z</dcterms:created>
  <dcterms:modified xsi:type="dcterms:W3CDTF">2019-07-31T07:42:30Z</dcterms:modified>
</cp:coreProperties>
</file>